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808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0380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9749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4566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8231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7778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2380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0693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5117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5618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2266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646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8FC42-D9AB-456B-B831-CBBD0C25019A}" type="datetimeFigureOut">
              <a:rPr lang="de-DE" smtClean="0"/>
              <a:t>18.05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BA700B-208F-484F-B67A-35B939A4549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120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525" y="2792920"/>
            <a:ext cx="1440000" cy="1440000"/>
          </a:xfrm>
          <a:prstGeom prst="rect">
            <a:avLst/>
          </a:prstGeom>
          <a:ln w="12700">
            <a:noFill/>
          </a:ln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6637" y="2792920"/>
            <a:ext cx="1440000" cy="14400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5224" y="2792920"/>
            <a:ext cx="1440000" cy="14400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3336" y="2792920"/>
            <a:ext cx="1440000" cy="144000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525" y="1306600"/>
            <a:ext cx="1440000" cy="144000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6637" y="1306600"/>
            <a:ext cx="1440000" cy="1440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5224" y="1306600"/>
            <a:ext cx="1440000" cy="144000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3336" y="1306600"/>
            <a:ext cx="1440000" cy="1440000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2796191" y="8841432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e-3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58525" y="129287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1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2045804" y="129287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2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3525224" y="129287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3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5018829" y="1292879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4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558525" y="279292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5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2045804" y="279292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6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3525224" y="279292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5018829" y="279292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8</a:t>
            </a:r>
            <a:endParaRPr lang="de-DE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4"/>
          <p:cNvCxnSpPr/>
          <p:nvPr/>
        </p:nvCxnSpPr>
        <p:spPr>
          <a:xfrm>
            <a:off x="6147736" y="4128505"/>
            <a:ext cx="2268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feld 20"/>
          <p:cNvSpPr txBox="1"/>
          <p:nvPr/>
        </p:nvSpPr>
        <p:spPr>
          <a:xfrm>
            <a:off x="656400" y="1095398"/>
            <a:ext cx="12442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K293-flotillin-1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2144512" y="1095398"/>
            <a:ext cx="12442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K293-flotillin-2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3570199" y="1095398"/>
            <a:ext cx="1350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K293-flotillin-1/2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5211398" y="1095398"/>
            <a:ext cx="1043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EK293-mock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274685" y="1539608"/>
            <a:ext cx="338554" cy="97398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0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FLOT1</a:t>
            </a:r>
            <a:endParaRPr lang="de-DE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274685" y="3025928"/>
            <a:ext cx="338554" cy="97398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de-DE" sz="10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S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0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FLOT2</a:t>
            </a:r>
            <a:endParaRPr lang="de-DE" sz="10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2880937" y="4194820"/>
            <a:ext cx="12715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S: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027376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A4-Papier (210x297 mm)</PresentationFormat>
  <Paragraphs>1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EUROIMMUN A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ahn, Stefanie</dc:creator>
  <cp:lastModifiedBy>Hahn, Stefanie</cp:lastModifiedBy>
  <cp:revision>31</cp:revision>
  <dcterms:created xsi:type="dcterms:W3CDTF">2015-08-27T11:58:00Z</dcterms:created>
  <dcterms:modified xsi:type="dcterms:W3CDTF">2017-05-18T10:46:13Z</dcterms:modified>
</cp:coreProperties>
</file>